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6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7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51E8A4-D2FC-4D0F-AB44-2C520973E992}" type="datetimeFigureOut">
              <a:rPr kumimoji="1" lang="ja-JP" altLang="en-US" smtClean="0"/>
              <a:t>2024/2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349422-E1F9-4F91-9915-C072BBCDC9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50516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519C17-4911-1D4A-A5F3-827220B365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73EA88C-0E83-0BC3-A09F-C7BC911075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7A189B-B735-72F1-AD79-AB6DC3D26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C9B72-45A0-4F70-A5E2-165C464FBB99}" type="datetimeFigureOut">
              <a:rPr kumimoji="1" lang="ja-JP" altLang="en-US" smtClean="0"/>
              <a:t>2024/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903F15-EBED-CDBA-EB07-81406E81B1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9C981CC-EF29-E78C-7D17-1C8C883F58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66B9D-30B3-44FF-8425-D1A2826000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610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6CF79D-B66B-9AC8-7037-C4914C0D81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8667794-8BD4-83EA-707F-9973EF129F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CFE6AB-D741-7A5E-968B-DCDAF71084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C9B72-45A0-4F70-A5E2-165C464FBB99}" type="datetimeFigureOut">
              <a:rPr kumimoji="1" lang="ja-JP" altLang="en-US" smtClean="0"/>
              <a:t>2024/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C2425FD-4AF3-48BD-6B16-FE9175EDC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3E89EE7-B59A-9CD7-C6E5-645DC581E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66B9D-30B3-44FF-8425-D1A2826000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5921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100208D-44E9-6AFB-B445-23874DB699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310EEA3-B1AC-A2AE-3CDF-C48B859284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24EAA50-999D-FFAB-ACE0-08563BCFF2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C9B72-45A0-4F70-A5E2-165C464FBB99}" type="datetimeFigureOut">
              <a:rPr kumimoji="1" lang="ja-JP" altLang="en-US" smtClean="0"/>
              <a:t>2024/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F356BD8-657C-4715-9E03-AC27862FF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191C87-5D30-E597-7259-31DA0A9D8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66B9D-30B3-44FF-8425-D1A2826000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6807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931884D-B44B-25BF-7778-3695ADE286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432A204-A586-36D8-58D1-7129C80440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83E4938-F3CC-8F80-487C-E4F08DE444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C9B72-45A0-4F70-A5E2-165C464FBB99}" type="datetimeFigureOut">
              <a:rPr kumimoji="1" lang="ja-JP" altLang="en-US" smtClean="0"/>
              <a:t>2024/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C86B95A-E563-6FAD-D747-AEEA3FC53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FFD5C17-34C7-10E8-7189-C042E871A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66B9D-30B3-44FF-8425-D1A2826000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4914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92BCFB9-993F-0BD0-2AAC-83B9533373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A297317-421C-9F9A-3277-43528A06DF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A2D7C4D-4035-771C-8181-1A9386D587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C9B72-45A0-4F70-A5E2-165C464FBB99}" type="datetimeFigureOut">
              <a:rPr kumimoji="1" lang="ja-JP" altLang="en-US" smtClean="0"/>
              <a:t>2024/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EE85F57-9562-023D-D1DE-901C1379D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7E03C9-0541-0CC9-7473-A025B4B82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66B9D-30B3-44FF-8425-D1A2826000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2363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06B518-E51E-FC73-DF23-1CFA63F322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6ED0F22-48AD-7D8D-191E-CB21DD61EC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7318BF5-AEA3-5807-C643-299745C8B9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7917381-709C-B384-C74F-40D9542EA4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C9B72-45A0-4F70-A5E2-165C464FBB99}" type="datetimeFigureOut">
              <a:rPr kumimoji="1" lang="ja-JP" altLang="en-US" smtClean="0"/>
              <a:t>2024/2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60FEE2A-D2E1-38A9-F175-3A30B52E1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8A5D76F-105A-A871-A1F6-A8007BB4D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66B9D-30B3-44FF-8425-D1A2826000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1916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BFDD0E-9F63-D65A-CEB5-7E42C99444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F857B60-139C-D456-E2F7-3152B1156D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5DBCE14-629A-995E-05E3-5E77C9CCAB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09569E1-0DCA-2ED1-BDB7-842D6EEC2B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37A5143-96DE-2AA5-D11A-3BE8775FF17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36E7E93-57B6-D63C-719D-4DE34F9647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C9B72-45A0-4F70-A5E2-165C464FBB99}" type="datetimeFigureOut">
              <a:rPr kumimoji="1" lang="ja-JP" altLang="en-US" smtClean="0"/>
              <a:t>2024/2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E95BAC4-6B66-594F-3123-92B1812C7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08D081C-4169-23A4-C3F7-5FF08612BE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66B9D-30B3-44FF-8425-D1A2826000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3127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AB7C98-AF8F-268F-FB59-29DD9DEC9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E664C2A-ECDA-5993-146B-34E16977DB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C9B72-45A0-4F70-A5E2-165C464FBB99}" type="datetimeFigureOut">
              <a:rPr kumimoji="1" lang="ja-JP" altLang="en-US" smtClean="0"/>
              <a:t>2024/2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2D7EF5E-9FED-C72A-3274-F88C2A6BA8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B142B3E-259B-D676-9FA3-4DF469E199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66B9D-30B3-44FF-8425-D1A2826000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9371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17850DB-D432-2F61-CEE8-6BD46E964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C9B72-45A0-4F70-A5E2-165C464FBB99}" type="datetimeFigureOut">
              <a:rPr kumimoji="1" lang="ja-JP" altLang="en-US" smtClean="0"/>
              <a:t>2024/2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3A15A52-1663-D703-8DA7-39F2813AD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9A632EC-423E-D050-D888-3CFDFE82F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66B9D-30B3-44FF-8425-D1A2826000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3906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63F7C3-AA61-CA23-CC58-50C37F4FAD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CA56DFB-D526-9CD3-24FE-362689905A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51470DE-FFB3-2843-0278-A8B87A0021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EB25F7A-43F5-D9E1-07CB-8FBF3C5D5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C9B72-45A0-4F70-A5E2-165C464FBB99}" type="datetimeFigureOut">
              <a:rPr kumimoji="1" lang="ja-JP" altLang="en-US" smtClean="0"/>
              <a:t>2024/2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6067AE4-99F3-2CDD-8EE4-D107E66C2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9CE7F45-E372-B48D-E0D4-026286726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66B9D-30B3-44FF-8425-D1A2826000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099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925E6A-2FC4-6621-6FB1-6C2BD2DA70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9F98912-DCF7-428E-49C0-751C8685C8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3DC4716-A188-12C0-9D68-409CE790BC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55375CB-5025-FC19-C36F-4417AFFDDF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C9B72-45A0-4F70-A5E2-165C464FBB99}" type="datetimeFigureOut">
              <a:rPr kumimoji="1" lang="ja-JP" altLang="en-US" smtClean="0"/>
              <a:t>2024/2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7AD8AAD-02C3-E5A7-F491-606300A2F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F9DB78A-4F8A-110C-D1F7-0DF1043602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66B9D-30B3-44FF-8425-D1A2826000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208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089E853-14D4-352E-102E-6F5AE2F5F3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48B8317-8FBA-EEC1-4883-BBC854FCA5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56A5BA-69E8-903E-4A4B-14E0F4D7DB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5C9B72-45A0-4F70-A5E2-165C464FBB99}" type="datetimeFigureOut">
              <a:rPr kumimoji="1" lang="ja-JP" altLang="en-US" smtClean="0"/>
              <a:t>2024/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E6A868-0D88-C18B-49FE-3D45447890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B8948A-3393-AAA0-7665-C072C7A131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A66B9D-30B3-44FF-8425-D1A2826000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45712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3B8DBBD-C4BB-49E8-93E3-06285544DB67}"/>
              </a:ext>
            </a:extLst>
          </p:cNvPr>
          <p:cNvSpPr txBox="1"/>
          <p:nvPr/>
        </p:nvSpPr>
        <p:spPr>
          <a:xfrm>
            <a:off x="729674" y="939294"/>
            <a:ext cx="1129607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xatives taken by patients in this study </a:t>
            </a:r>
            <a:r>
              <a:rPr lang="ja-JP" alt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tipation patients </a:t>
            </a:r>
            <a:r>
              <a:rPr lang="en-US" altLang="ja-JP" sz="2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ja-JP" altLang="en-US" sz="2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124</a:t>
            </a:r>
            <a:r>
              <a:rPr lang="ja-JP" alt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en-US" altLang="ja-JP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en-US" altLang="ja-JP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89131ABE-E20B-49D9-A772-B0B41AE077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3166465"/>
              </p:ext>
            </p:extLst>
          </p:nvPr>
        </p:nvGraphicFramePr>
        <p:xfrm>
          <a:off x="1588655" y="1893401"/>
          <a:ext cx="8534400" cy="448964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830618">
                  <a:extLst>
                    <a:ext uri="{9D8B030D-6E8A-4147-A177-3AD203B41FA5}">
                      <a16:colId xmlns:a16="http://schemas.microsoft.com/office/drawing/2014/main" val="457580227"/>
                    </a:ext>
                  </a:extLst>
                </a:gridCol>
                <a:gridCol w="3703782">
                  <a:extLst>
                    <a:ext uri="{9D8B030D-6E8A-4147-A177-3AD203B41FA5}">
                      <a16:colId xmlns:a16="http://schemas.microsoft.com/office/drawing/2014/main" val="3004695597"/>
                    </a:ext>
                  </a:extLst>
                </a:gridCol>
              </a:tblGrid>
              <a:tr h="748274">
                <a:tc>
                  <a:txBody>
                    <a:bodyPr/>
                    <a:lstStyle/>
                    <a:p>
                      <a:r>
                        <a:rPr kumimoji="1" lang="en-US" altLang="ja-JP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ugs</a:t>
                      </a:r>
                      <a:endParaRPr kumimoji="1" lang="ja-JP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ient numbers (n)</a:t>
                      </a:r>
                      <a:endParaRPr kumimoji="1" lang="ja-JP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8231908"/>
                  </a:ext>
                </a:extLst>
              </a:tr>
              <a:tr h="748274">
                <a:tc>
                  <a:txBody>
                    <a:bodyPr/>
                    <a:lstStyle/>
                    <a:p>
                      <a:r>
                        <a:rPr kumimoji="1" lang="en-US" altLang="ja-JP" sz="28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nnoside</a:t>
                      </a:r>
                      <a:endParaRPr kumimoji="1" lang="ja-JP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kumimoji="1" lang="ja-JP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719745554"/>
                  </a:ext>
                </a:extLst>
              </a:tr>
              <a:tr h="748274">
                <a:tc>
                  <a:txBody>
                    <a:bodyPr/>
                    <a:lstStyle/>
                    <a:p>
                      <a:r>
                        <a:rPr kumimoji="1" lang="en-US" altLang="ja-JP" sz="28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nnoside + </a:t>
                      </a:r>
                      <a:r>
                        <a:rPr lang="en-US" altLang="ja-JP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gnesium oxide</a:t>
                      </a:r>
                      <a:endParaRPr kumimoji="1" lang="ja-JP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8433143"/>
                  </a:ext>
                </a:extLst>
              </a:tr>
              <a:tr h="748274">
                <a:tc>
                  <a:txBody>
                    <a:bodyPr/>
                    <a:lstStyle/>
                    <a:p>
                      <a:r>
                        <a:rPr lang="en-US" altLang="ja-JP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gnesium oxide</a:t>
                      </a:r>
                      <a:endParaRPr kumimoji="1" lang="ja-JP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</a:t>
                      </a:r>
                      <a:endParaRPr kumimoji="1" lang="ja-JP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25928498"/>
                  </a:ext>
                </a:extLst>
              </a:tr>
              <a:tr h="748274">
                <a:tc>
                  <a:txBody>
                    <a:bodyPr/>
                    <a:lstStyle/>
                    <a:p>
                      <a:r>
                        <a:rPr lang="en-US" altLang="ja-JP" sz="28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cosulfate</a:t>
                      </a:r>
                      <a:endParaRPr kumimoji="1" lang="ja-JP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80033664"/>
                  </a:ext>
                </a:extLst>
              </a:tr>
              <a:tr h="74827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800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biprostone</a:t>
                      </a:r>
                      <a:endParaRPr kumimoji="1" lang="ja-JP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kumimoji="1" lang="ja-JP" altLang="en-US" sz="2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7062898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87610D6-9D40-4041-A3C3-51D8A9856C67}"/>
              </a:ext>
            </a:extLst>
          </p:cNvPr>
          <p:cNvSpPr txBox="1"/>
          <p:nvPr/>
        </p:nvSpPr>
        <p:spPr>
          <a:xfrm>
            <a:off x="7518400" y="166255"/>
            <a:ext cx="436048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imentary</a:t>
            </a:r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1</a:t>
            </a:r>
            <a:endParaRPr kumimoji="1" lang="ja-JP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0056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</TotalTime>
  <Words>37</Words>
  <Application>Microsoft Office PowerPoint</Application>
  <PresentationFormat>ワイド画面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智滉 石田</dc:creator>
  <cp:lastModifiedBy>Pharmacy</cp:lastModifiedBy>
  <cp:revision>6</cp:revision>
  <cp:lastPrinted>2024-01-18T09:26:23Z</cp:lastPrinted>
  <dcterms:created xsi:type="dcterms:W3CDTF">2023-11-15T14:03:39Z</dcterms:created>
  <dcterms:modified xsi:type="dcterms:W3CDTF">2024-02-08T12:42:51Z</dcterms:modified>
</cp:coreProperties>
</file>